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-630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11BDC85-9ED0-42CF-8CA2-5E8942AEFE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742DD27D-5BAF-4EA3-B9B9-A4CE596AD4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757CA53-E5DF-43B4-B94A-A34AA24F4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6B75FFB-2160-4D97-85F8-EE748F703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7E05B5C-AA61-4FAE-BD17-476CD67F5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9741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AA5812F-4E75-4370-9224-936F1CFC14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8303BE4C-56B7-4BF8-B366-1514D0AF69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3088AF6-3671-441D-930C-8488F3540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D4C3D57-7BE9-4FC8-BE2E-6D677651F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5EA5E1A-FA63-4BFF-8CB2-27DE367E2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615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7D2BBF27-6756-47A7-AFF1-9F9C7E74FF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1813577B-5383-4B84-8680-1710A0A5D3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893509C-9923-4E08-A28B-00174B26E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372FD3B-CE8E-4E39-B0BA-3E76ABFCC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F01E42D-4C25-4EF2-8C94-36508D3F6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35545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2FF7095-4F16-4FBF-95AE-66AD192E6D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9FBBD3C-3018-4355-8CC6-FB3ADE26E4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9E4386D-BE4D-40A5-A065-F5BDF2CF4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8959CEE-40DD-4211-9A42-5C111A92C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75FAAB3-F1DE-49A5-AA0F-BE88464F5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1217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1985C1B-2D52-42F9-8A7C-239FB1719E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ADA841D-C035-488D-AD74-09014AB658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3A44F54-58AC-4FF6-9094-5D481CC63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6F1CDE7-202B-4D12-A9FA-F725BAC81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AC3D96B-8ACF-4CA5-836D-50FA5AADF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9945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A9459B2-BC7A-4AF8-8545-2D1D24764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26D9EFD9-4003-452B-AEE8-8AAFA05889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DEE5E703-E469-424C-AFD2-366E9D6B24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9CD2E368-79BB-46D3-951D-B9610DA15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7B05F767-C69B-468C-8560-A185B79A7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A423FBE-C5EF-4C4D-A2AB-7AB5B8113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0670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C9604C8-628D-4253-BE90-192168E89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A837548-01F9-4AB4-B467-254C1A2CF2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44618547-A5DF-4DEA-A6CC-94723668F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8FA65A3E-EA32-4201-985A-8990B190C5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42531C16-3EDE-4098-9F70-181E362D67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64AC3B4F-811A-46CF-83A1-212EF5B73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DBC84BF2-9D9D-4A6B-AED0-0ED4F17A8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AE7304B6-A77E-4FAA-B90C-44682FCCD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6846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015E647-7A62-4E15-BA4F-2F928EA0B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A604CF3E-24DF-40C4-BE24-78844EB024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DD62A09A-0DAF-41FB-B924-EEE5D08A2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E6727B36-37C8-4F66-BD0A-11DCE3AB6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53898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F264460A-D716-4BBD-8E6A-CD7DF3C98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0432015A-BCCA-48F8-8187-BC1D600DB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47591567-23D1-4AA4-BCCE-B124B7FCC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74777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C1E61FA-AA39-41F4-BBF4-E638C999D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DD4BB896-49E0-4733-A150-46E35489C5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2719C54-24A4-48C5-B0A7-7036983A56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265621E-EC0E-4093-9CA9-D3200DA0A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9D95E02-A019-4C15-875E-F6428205D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D7A860D7-FADB-47C9-88C3-90C0E2EAC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8347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C1B9D11-A981-44EF-9AD8-418BF2B26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7413CF70-DF81-4966-8E25-631E97FE21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042570E-778A-4554-95E1-00918C58EB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5752688-74F5-481A-B4A3-627CC61CC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04B53CE2-60F8-4509-852A-687EE24F1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F2718AF2-6556-4E46-9161-A9EE58117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30911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41464506-E593-4225-9219-2B6DD36D8F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107E5383-6BF5-44D9-803A-D54C7D70E8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F360DB6-7EEA-4FCC-BB73-DEE10BF38C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D71DF-F729-41E8-BBBA-BC4B07F26F2D}" type="datetimeFigureOut">
              <a:rPr lang="en-IN" smtClean="0"/>
              <a:t>11-01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1218E69-A743-40EC-A4BC-DC435F0C9B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7356C15-EA3D-4E04-9003-C4C282A93E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DD12F-AE35-4106-8E1B-9B4D621DCC10}" type="slidenum">
              <a:rPr lang="en-IN" smtClean="0"/>
              <a:t>‹Nr.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71058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>
            <a:extLst>
              <a:ext uri="{FF2B5EF4-FFF2-40B4-BE49-F238E27FC236}">
                <a16:creationId xmlns="" xmlns:a16="http://schemas.microsoft.com/office/drawing/2014/main" id="{3B51E9EE-0760-4CBF-91D3-21A0908CD57B}"/>
              </a:ext>
            </a:extLst>
          </p:cNvPr>
          <p:cNvSpPr/>
          <p:nvPr/>
        </p:nvSpPr>
        <p:spPr>
          <a:xfrm rot="16200000">
            <a:off x="408750" y="2986381"/>
            <a:ext cx="20786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/>
              <a:t>Percentage of gene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3D2C287A-7F34-457D-8D7F-536A8ADE76E6}"/>
              </a:ext>
            </a:extLst>
          </p:cNvPr>
          <p:cNvSpPr/>
          <p:nvPr/>
        </p:nvSpPr>
        <p:spPr>
          <a:xfrm>
            <a:off x="3532036" y="5758807"/>
            <a:ext cx="16273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dirty="0"/>
              <a:t>Number of CDS</a:t>
            </a:r>
          </a:p>
        </p:txBody>
      </p:sp>
      <p:sp>
        <p:nvSpPr>
          <p:cNvPr id="18" name="Oval 17">
            <a:extLst>
              <a:ext uri="{FF2B5EF4-FFF2-40B4-BE49-F238E27FC236}">
                <a16:creationId xmlns="" xmlns:a16="http://schemas.microsoft.com/office/drawing/2014/main" id="{6E3F6956-1E61-43A3-B103-0562396620B8}"/>
              </a:ext>
            </a:extLst>
          </p:cNvPr>
          <p:cNvSpPr/>
          <p:nvPr/>
        </p:nvSpPr>
        <p:spPr>
          <a:xfrm>
            <a:off x="7911213" y="2521297"/>
            <a:ext cx="81280" cy="71120"/>
          </a:xfrm>
          <a:prstGeom prst="ellipse">
            <a:avLst/>
          </a:prstGeom>
          <a:solidFill>
            <a:schemeClr val="bg1"/>
          </a:solidFill>
          <a:ln w="1270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9" name="Oval 18">
            <a:extLst>
              <a:ext uri="{FF2B5EF4-FFF2-40B4-BE49-F238E27FC236}">
                <a16:creationId xmlns="" xmlns:a16="http://schemas.microsoft.com/office/drawing/2014/main" id="{E4FCEC9B-7B88-4F56-8FC4-E9DB5D303590}"/>
              </a:ext>
            </a:extLst>
          </p:cNvPr>
          <p:cNvSpPr/>
          <p:nvPr/>
        </p:nvSpPr>
        <p:spPr>
          <a:xfrm>
            <a:off x="7911213" y="2790051"/>
            <a:ext cx="81280" cy="71120"/>
          </a:xfrm>
          <a:prstGeom prst="ellipse">
            <a:avLst/>
          </a:prstGeom>
          <a:solidFill>
            <a:schemeClr val="bg1"/>
          </a:solidFill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0" name="Oval 19">
            <a:extLst>
              <a:ext uri="{FF2B5EF4-FFF2-40B4-BE49-F238E27FC236}">
                <a16:creationId xmlns="" xmlns:a16="http://schemas.microsoft.com/office/drawing/2014/main" id="{A73A42C9-49EB-4AA6-A46B-CB65FD11D61E}"/>
              </a:ext>
            </a:extLst>
          </p:cNvPr>
          <p:cNvSpPr/>
          <p:nvPr/>
        </p:nvSpPr>
        <p:spPr>
          <a:xfrm>
            <a:off x="7911213" y="3054413"/>
            <a:ext cx="81280" cy="7112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E236133F-FA38-4A87-AE66-92360945E75F}"/>
              </a:ext>
            </a:extLst>
          </p:cNvPr>
          <p:cNvSpPr txBox="1"/>
          <p:nvPr/>
        </p:nvSpPr>
        <p:spPr>
          <a:xfrm>
            <a:off x="8231399" y="2915174"/>
            <a:ext cx="2390319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IN" i="1" dirty="0" err="1"/>
              <a:t>Castanea</a:t>
            </a:r>
            <a:r>
              <a:rPr lang="en-IN" i="1" dirty="0"/>
              <a:t> </a:t>
            </a:r>
            <a:r>
              <a:rPr lang="en-IN" i="1" dirty="0" err="1"/>
              <a:t>mollissima</a:t>
            </a:r>
            <a:endParaRPr lang="en-US" dirty="0" err="1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82DB3FBE-B968-4358-8B1C-3EA34697E33D}"/>
              </a:ext>
            </a:extLst>
          </p:cNvPr>
          <p:cNvSpPr txBox="1"/>
          <p:nvPr/>
        </p:nvSpPr>
        <p:spPr>
          <a:xfrm>
            <a:off x="8231399" y="3209205"/>
            <a:ext cx="2390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i="1" dirty="0"/>
              <a:t>Arabidopsis thalian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90D4EB30-71CE-4A61-9FEF-9B8ED48283E9}"/>
              </a:ext>
            </a:extLst>
          </p:cNvPr>
          <p:cNvSpPr txBox="1"/>
          <p:nvPr/>
        </p:nvSpPr>
        <p:spPr>
          <a:xfrm>
            <a:off x="8231399" y="2341578"/>
            <a:ext cx="2381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i="1" dirty="0"/>
              <a:t>Fagus </a:t>
            </a:r>
            <a:r>
              <a:rPr lang="en-IN" i="1" dirty="0" smtClean="0"/>
              <a:t>sylvatica </a:t>
            </a:r>
            <a:endParaRPr lang="en-IN" i="1" dirty="0"/>
          </a:p>
        </p:txBody>
      </p:sp>
      <p:sp>
        <p:nvSpPr>
          <p:cNvPr id="25" name="Oval 24">
            <a:extLst>
              <a:ext uri="{FF2B5EF4-FFF2-40B4-BE49-F238E27FC236}">
                <a16:creationId xmlns="" xmlns:a16="http://schemas.microsoft.com/office/drawing/2014/main" id="{4C785C51-BE1C-4AA9-89AE-289DB9B9F96E}"/>
              </a:ext>
            </a:extLst>
          </p:cNvPr>
          <p:cNvSpPr/>
          <p:nvPr/>
        </p:nvSpPr>
        <p:spPr>
          <a:xfrm>
            <a:off x="7911213" y="3314819"/>
            <a:ext cx="81280" cy="7112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CF68D526-E08B-49D0-861D-35493FA4AF3C}"/>
              </a:ext>
            </a:extLst>
          </p:cNvPr>
          <p:cNvSpPr txBox="1"/>
          <p:nvPr/>
        </p:nvSpPr>
        <p:spPr>
          <a:xfrm>
            <a:off x="8231399" y="2614868"/>
            <a:ext cx="2390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i="1" dirty="0" err="1"/>
              <a:t>Populus</a:t>
            </a:r>
            <a:r>
              <a:rPr lang="en-IN" i="1" dirty="0"/>
              <a:t> </a:t>
            </a:r>
            <a:r>
              <a:rPr lang="en-IN" i="1" dirty="0" err="1"/>
              <a:t>trichocarpa</a:t>
            </a:r>
            <a:endParaRPr lang="en-IN" i="1" dirty="0"/>
          </a:p>
        </p:txBody>
      </p:sp>
      <p:pic>
        <p:nvPicPr>
          <p:cNvPr id="28" name="Picture 28" descr="Rplot.jpeg">
            <a:extLst>
              <a:ext uri="{FF2B5EF4-FFF2-40B4-BE49-F238E27FC236}">
                <a16:creationId xmlns="" xmlns:a16="http://schemas.microsoft.com/office/drawing/2014/main" id="{91C763DA-86E0-47AF-B7B6-2BA5A4F5388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02" t="11012" r="5004" b="8548"/>
          <a:stretch/>
        </p:blipFill>
        <p:spPr>
          <a:xfrm>
            <a:off x="1822907" y="954516"/>
            <a:ext cx="5045628" cy="4529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8628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Office PowerPoint</Application>
  <PresentationFormat>Benutzerdefiniert</PresentationFormat>
  <Paragraphs>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gdevi Mishra</dc:creator>
  <cp:lastModifiedBy>Marco Thines</cp:lastModifiedBy>
  <cp:revision>8</cp:revision>
  <dcterms:created xsi:type="dcterms:W3CDTF">2018-01-11T12:37:29Z</dcterms:created>
  <dcterms:modified xsi:type="dcterms:W3CDTF">2018-01-11T16:15:28Z</dcterms:modified>
</cp:coreProperties>
</file>